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AF9CEC-12F0-4EBE-A452-00F009309E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9563806-9897-4578-8898-54D4B5263C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D06666-01D0-48A0-90B7-9321A25FA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A0EC32-D1EC-4517-9775-FAC285809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A7B8D2-AE4F-4FAC-A69C-3C3C18343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53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C33250-EC9A-4EF3-A4F1-9752D0A57B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710017E-8C51-481C-8B39-76289CC884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96D327-F2E6-431F-91D4-4FDDA1A3F9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96F3BD-F539-4CB9-B67F-E6C46A7CE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0D23B0-7809-4AC9-92FE-48810FF07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3445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DB72C98-D475-485C-AF84-BE0E8F3BE2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066297E-548D-48B9-945C-FDC1E2668C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06EAF1E-F8AF-4CE1-8EAA-4D67F48CD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3356ED-6569-4226-8D6E-7D2502CE5D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5CADCA-30BE-40BB-85D0-A33984415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9444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A172E5-563B-4153-94E7-C4E5C019A8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D899C5A-1A65-413F-902B-41EA053105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82FABA-B3B3-4430-B22B-C610199A0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DBF0367-BC97-4D7E-90BC-F56327C79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C991A9-9A55-4C7A-AED9-0DBDB662E7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4858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2E7FE6-CC95-4436-9365-DF44D77C7B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1C88289-C002-448F-9757-7674EC685D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E4F7E8-FAC1-4B68-94EE-D02A8EB04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993F6C-2190-42FD-804E-B0370DF49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361C05E-306E-4460-B548-2A3737FA4E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1480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45C707-0324-4D64-BA92-343F6CE03F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A499B88-773A-4ADE-9450-5D70722ADF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1677D2F-2954-4013-8B43-8B814479ED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1372DED-F002-4E19-8765-C22B6789D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8020A69-E9C3-48E5-92B4-3F55DBB950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2CE427A-4F06-4EC5-8649-9C0DFDBDF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847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BEE67C-CF69-4200-BAF8-DDAE62DC66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4C4E297-483E-4ADC-95CE-2861D4D718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8D5332B-BF7E-44FD-80D9-58D0109742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ED70A56-0F6D-4ED9-B452-6023521C62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2B90282-FF29-480F-8B21-F037B4CC2B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6CCA05F-A351-48DB-BABE-1767E0AE92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6E51D34-07EA-45EE-9707-FD9403E257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E28B082-6EF7-48CE-BF76-47200B765E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9908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6795DC-770E-4441-80AA-FA3708A06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89787BE-6DDD-4C34-8FB5-DB98FCB18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7411588-C59D-4F5A-91C9-FAFE2A7C4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BFEE93A-ED77-4C21-BF96-7698FED08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0317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03CBBC7-3CDB-4E00-A6DC-1BABB922B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F3B0F30-588F-4DCE-8CE9-180528FD1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E8BE049-49AF-4982-8600-558F658485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4021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3D4F0F-D810-49E7-B808-9196D986D5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23A5C53-2BDC-4AC9-9C4C-81843F7824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B3DAD1C-1F2C-4B82-916B-7E8D7025AF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08F1454-F568-4ED9-B999-74740E873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9536A57-0EFB-4B2D-9589-B195FAD50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56115DD-776B-43F3-9E12-ED0D86BFB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35251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27BC21-32B3-465E-95C2-6CD71194E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036FDCD-F1C8-4ABD-8F6B-8B3D61E03D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FCFC1A7-228C-4489-BF10-6DEB85B39C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9AAF59B-838B-44E5-9D94-696A864DF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92C3738-B051-4B1F-8C4A-2B668C2A7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62DACE1-FEA4-4CD8-8421-7AA92B015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6770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2095C5D-81AF-424A-A697-649D94FA93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564F67F-A14F-481B-AA13-DF582DA9DE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BFC989-E784-45FA-A6F5-3E338CA220F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891060-1809-4B23-A1DA-7E7AB2311CFF}" type="datetimeFigureOut">
              <a:rPr lang="zh-CN" altLang="en-US" smtClean="0"/>
              <a:t>2021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0404430-3762-489D-BA26-BE9D1AE895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C03AD6-8149-4AF8-B6C4-D36CFB1AC2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2515C8-3C30-4997-A8C9-FFCB192727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639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724FA99B-FB4E-4075-AB7A-5897F2E0ECEA}"/>
              </a:ext>
            </a:extLst>
          </p:cNvPr>
          <p:cNvSpPr txBox="1"/>
          <p:nvPr/>
        </p:nvSpPr>
        <p:spPr>
          <a:xfrm>
            <a:off x="3048000" y="3244334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Bef>
                <a:spcPts val="1200"/>
              </a:spcBef>
              <a:spcAft>
                <a:spcPts val="600"/>
              </a:spcAft>
            </a:pPr>
            <a:r>
              <a:rPr lang="en-US" altLang="zh-CN" sz="3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Material</a:t>
            </a:r>
            <a:endParaRPr lang="zh-CN" altLang="zh-CN" sz="3200" b="1" i="1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189573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4936927E-8030-492D-BD12-8176BCC4104E}"/>
              </a:ext>
            </a:extLst>
          </p:cNvPr>
          <p:cNvSpPr txBox="1"/>
          <p:nvPr/>
        </p:nvSpPr>
        <p:spPr>
          <a:xfrm>
            <a:off x="254000" y="1455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Supplementary Figure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84F6C48-D7FF-44F8-B0D6-D1758817756D}"/>
              </a:ext>
            </a:extLst>
          </p:cNvPr>
          <p:cNvSpPr txBox="1"/>
          <p:nvPr/>
        </p:nvSpPr>
        <p:spPr>
          <a:xfrm>
            <a:off x="2546603" y="4457115"/>
            <a:ext cx="709879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.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EM images of neat PEEK coating with PDA nanofilm for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0 h,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 h,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6 h,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12 h,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4 h and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F)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48 h.</a:t>
            </a:r>
            <a:endParaRPr lang="zh-CN" altLang="zh-CN" sz="18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8BEB6165-1B00-4B57-A461-A4F86570AD23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1802" y="622583"/>
            <a:ext cx="6208395" cy="364553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5441842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35AF637-6138-4304-B95E-96459163C5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5976" y="92948"/>
            <a:ext cx="6480048" cy="5986272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9CE52E21-CEB7-456A-AF0E-1D0F328B5919}"/>
              </a:ext>
            </a:extLst>
          </p:cNvPr>
          <p:cNvSpPr txBox="1"/>
          <p:nvPr/>
        </p:nvSpPr>
        <p:spPr>
          <a:xfrm>
            <a:off x="1960880" y="6118721"/>
            <a:ext cx="881888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Figure S2.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Photographs of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A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neat PEEK,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B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plasma-treatment PEEK,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C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PDA coated PEEK (24 h), and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D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plasma pretreated and PDA coated PEEK (24 h)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615504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CDF6D95E-E038-41A0-B4B1-0EE73F6F74DA}"/>
              </a:ext>
            </a:extLst>
          </p:cNvPr>
          <p:cNvSpPr txBox="1"/>
          <p:nvPr/>
        </p:nvSpPr>
        <p:spPr>
          <a:xfrm>
            <a:off x="1676400" y="4538395"/>
            <a:ext cx="91643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Figure S3.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XPS C1s spectra of neat PEEK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A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and plasma-treated PEEK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B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22B8FB26-5917-42B8-983C-F55D7C3B00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5976" y="1861312"/>
            <a:ext cx="6480048" cy="23835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96805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444421EA-612D-4E79-9CF9-1EB04DC10FD8}"/>
              </a:ext>
            </a:extLst>
          </p:cNvPr>
          <p:cNvSpPr txBox="1"/>
          <p:nvPr/>
        </p:nvSpPr>
        <p:spPr>
          <a:xfrm>
            <a:off x="1539240" y="5633565"/>
            <a:ext cx="911352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4.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chematic sketch portraying the lap-shear test process of the PEEK film to the dentin substrate of primary molar teeth.</a:t>
            </a:r>
            <a:endParaRPr lang="zh-CN" altLang="zh-CN" sz="18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43948C0D-0282-4ED6-8DEA-DAD6FFDD8F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5976" y="360172"/>
            <a:ext cx="6480048" cy="50200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33118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Supplementary Movie S1">
            <a:hlinkClick r:id="" action="ppaction://media"/>
            <a:extLst>
              <a:ext uri="{FF2B5EF4-FFF2-40B4-BE49-F238E27FC236}">
                <a16:creationId xmlns:a16="http://schemas.microsoft.com/office/drawing/2014/main" id="{4DCDE0E9-9043-4BA7-BBC7-FB37C5607D7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137150" y="1707515"/>
            <a:ext cx="1714500" cy="3048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10C7540-F9BB-4913-8769-A3B1FF69A01C}"/>
              </a:ext>
            </a:extLst>
          </p:cNvPr>
          <p:cNvSpPr txBox="1"/>
          <p:nvPr/>
        </p:nvSpPr>
        <p:spPr>
          <a:xfrm>
            <a:off x="203200" y="10489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spcBef>
                <a:spcPts val="1200"/>
              </a:spcBef>
              <a:spcAft>
                <a:spcPts val="1200"/>
              </a:spcAft>
            </a:pPr>
            <a:r>
              <a:rPr lang="en-US" altLang="zh-CN" sz="1800" b="1" kern="0" dirty="0">
                <a:effectLst/>
                <a:latin typeface="Times New Roman" panose="02020603050405020304" pitchFamily="18" charset="0"/>
                <a:ea typeface="Cambria" panose="02040503050406030204" pitchFamily="18" charset="0"/>
              </a:rPr>
              <a:t>2 Supplementary Movies</a:t>
            </a:r>
            <a:endParaRPr lang="zh-CN" altLang="zh-CN" sz="1800" b="1" kern="0" dirty="0">
              <a:effectLst/>
              <a:latin typeface="Times New Roman" panose="02020603050405020304" pitchFamily="18" charset="0"/>
              <a:ea typeface="Cambria" panose="020405030504060302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7345713-18F2-4F9D-B5C8-0A36C6F2770E}"/>
              </a:ext>
            </a:extLst>
          </p:cNvPr>
          <p:cNvSpPr txBox="1"/>
          <p:nvPr/>
        </p:nvSpPr>
        <p:spPr>
          <a:xfrm>
            <a:off x="1503680" y="5341035"/>
            <a:ext cx="91846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Movie S1.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Neat PEEK films adhered by GIC to withstand the weight of 200 g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8308408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Supplementary Movie S2">
            <a:hlinkClick r:id="" action="ppaction://media"/>
            <a:extLst>
              <a:ext uri="{FF2B5EF4-FFF2-40B4-BE49-F238E27FC236}">
                <a16:creationId xmlns:a16="http://schemas.microsoft.com/office/drawing/2014/main" id="{4173C7C6-A984-4E6F-8577-4AB2583F25E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238750" y="1433195"/>
            <a:ext cx="1714500" cy="3048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8AB0F006-2783-499D-9614-7E52A71B2401}"/>
              </a:ext>
            </a:extLst>
          </p:cNvPr>
          <p:cNvSpPr txBox="1"/>
          <p:nvPr/>
        </p:nvSpPr>
        <p:spPr>
          <a:xfrm>
            <a:off x="1112520" y="5101639"/>
            <a:ext cx="996696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Movie S2.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lasma-treated PEEK coated with PDA for 24 h adhered by GIC to withstand the weight of 2 kg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19712352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4</Words>
  <Application>Microsoft Office PowerPoint</Application>
  <PresentationFormat>Widescreen</PresentationFormat>
  <Paragraphs>9</Paragraphs>
  <Slides>7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雨晨 孟</dc:creator>
  <cp:lastModifiedBy>Frontiers Media SA</cp:lastModifiedBy>
  <cp:revision>23</cp:revision>
  <dcterms:created xsi:type="dcterms:W3CDTF">2020-11-15T11:59:11Z</dcterms:created>
  <dcterms:modified xsi:type="dcterms:W3CDTF">2021-01-28T16:54:33Z</dcterms:modified>
</cp:coreProperties>
</file>